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4" r:id="rId3"/>
    <p:sldId id="263" r:id="rId4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216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6038C1-63E6-4488-89C6-A04625E992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9384A20-FB2F-456E-BC48-EEA93D73A9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59A82C-5291-4389-BE5C-BCB6D87DE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D8307C3-FDA6-48BD-BED8-AC0A91C7C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033FC31-2C45-4143-81C1-72C0E4ECA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923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104850-368E-4AD7-AB6D-5B2CD60E8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0036623-34C7-4039-89A7-B415F7F85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1F06D88-BDD4-4A3D-BB03-B6C07B49A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5711061-7712-4F64-A589-68B25C6EC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48B5C80-A999-45E1-8794-963B39499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7644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037E96B-4797-439A-9BB1-1E2FE80764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F349A53-BEC0-4720-8BD9-53D12DEAAD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EFB9642-375D-4C69-B5EC-FF259471A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A3C441-B69E-41B3-8E15-EC6EB74E3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D7B28D5-3C93-4744-B465-8F3AE95DF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22674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3E7BB7-1004-433F-8990-97166CAB2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1A08218-C727-4842-BED5-450984E2C1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50ED937-4589-4583-8317-ED4602580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4E65064-B329-4C20-BD54-61F5D71EF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DDE0BD5-0590-48B0-9CB2-68C73D40D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60308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6FC7FE-FD3A-43DD-B576-EFEB22E816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DC4DD9A-2B54-46F0-8F35-07FB5283E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901BD8-08FE-4BB2-82D9-AA5CD07FB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4F518F-41B2-4945-9C0E-8FC10F0B5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47815F-3918-46FB-B6EE-459B844EF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0566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38F61BD-AB60-429B-93BD-A581AF654D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ED6C98E-1DBE-4536-87B0-16213E19AB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9FC1030-6E53-4BE5-95F4-3F773C9E2C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AAD827A-8D7C-478A-A17A-4E00AFA06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78A64CD-3601-42FC-B019-F47C9275B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3AC215C-E398-4280-9CF5-C8F95D652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08091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73016D-7B10-4D4A-ACC8-D7A37C4A1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084ACDD-E8CB-43C5-9467-B621CE2D7B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25CD10A-2936-4976-844F-1BA5368425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44D4270-8C0E-42B5-909A-1EF2BDFAE0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1441D5B-2FA5-4C92-8EC0-C3FC690C04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8FB5434-A093-44F0-83B6-D2228E8C3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3C006D0-DF6B-4190-A04A-364AC5102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83FE28F-5133-4813-9504-90EC5620F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52965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0CD3C8-7E62-462F-A1AC-BF755EA00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0D2E16D-A475-4DD2-8521-BE4CDE659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CFA62E6-DD33-489A-9C65-C28D240B6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1E98EF6-E442-4B1C-9EC1-B7A95EE1C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51763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CAF9280-D610-4A22-8E1F-446D34F2F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A76FED8-33FC-4AE0-9E68-27531DAC6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B5320F1-37B6-4D7B-A592-A647FE4C9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66894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3BEEEC-35EB-4BF0-8CC5-8C9CEE812B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B14F730-3461-4F7C-8324-1B42252913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89C3F6B-7D0C-4CAE-A2EF-402CE70F1A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9E85677-13FC-4946-8912-A41AD5602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8424C52-E6CD-4FD5-B567-FBDB6A9A7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F2A34F-A609-4489-97C2-463A02925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79231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0ECB45-FBF1-4E5B-8FC4-17A3BCCC3C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D026C6C-E963-4035-9656-8F5DAD8E06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A3A3410-E2ED-437B-AEDE-E290153EA8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49966B3-B1AF-41D5-AB69-BA038C9E6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14A14AE-7396-45C2-AA6D-4E17D1EF4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C4EC61E-D0FD-4F4B-AF93-CF9118F26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32198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809F5D1-1C2A-4CD0-8F83-66EFB2CF6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DC7739D-319C-4ADC-A3F5-5F02ACD217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0F57094-110F-4AF1-9020-9DC805AFC4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7688E-7242-44A1-A0F8-43F797362D3B}" type="datetimeFigureOut">
              <a:rPr lang="es-MX" smtClean="0"/>
              <a:t>30/01/20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2E527DB-0E12-40F7-B347-303B79D9B8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EACC45A-A38A-4278-833A-45F15D2EC3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4F91D-59B3-49E0-8E42-AF9FC5AC3702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1175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Marcador de contenido 3">
            <a:extLst>
              <a:ext uri="{FF2B5EF4-FFF2-40B4-BE49-F238E27FC236}">
                <a16:creationId xmlns:a16="http://schemas.microsoft.com/office/drawing/2014/main" id="{8A253C27-428E-473E-B308-294CF6595EB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55671682"/>
              </p:ext>
            </p:extLst>
          </p:nvPr>
        </p:nvGraphicFramePr>
        <p:xfrm>
          <a:off x="2426267" y="1385946"/>
          <a:ext cx="7212916" cy="2744988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393212">
                  <a:extLst>
                    <a:ext uri="{9D8B030D-6E8A-4147-A177-3AD203B41FA5}">
                      <a16:colId xmlns:a16="http://schemas.microsoft.com/office/drawing/2014/main" val="3824786091"/>
                    </a:ext>
                  </a:extLst>
                </a:gridCol>
                <a:gridCol w="1243631">
                  <a:extLst>
                    <a:ext uri="{9D8B030D-6E8A-4147-A177-3AD203B41FA5}">
                      <a16:colId xmlns:a16="http://schemas.microsoft.com/office/drawing/2014/main" val="1303156782"/>
                    </a:ext>
                  </a:extLst>
                </a:gridCol>
                <a:gridCol w="1151752">
                  <a:extLst>
                    <a:ext uri="{9D8B030D-6E8A-4147-A177-3AD203B41FA5}">
                      <a16:colId xmlns:a16="http://schemas.microsoft.com/office/drawing/2014/main" val="2429998982"/>
                    </a:ext>
                  </a:extLst>
                </a:gridCol>
                <a:gridCol w="1312360">
                  <a:extLst>
                    <a:ext uri="{9D8B030D-6E8A-4147-A177-3AD203B41FA5}">
                      <a16:colId xmlns:a16="http://schemas.microsoft.com/office/drawing/2014/main" val="1472436076"/>
                    </a:ext>
                  </a:extLst>
                </a:gridCol>
                <a:gridCol w="465186">
                  <a:extLst>
                    <a:ext uri="{9D8B030D-6E8A-4147-A177-3AD203B41FA5}">
                      <a16:colId xmlns:a16="http://schemas.microsoft.com/office/drawing/2014/main" val="4224070195"/>
                    </a:ext>
                  </a:extLst>
                </a:gridCol>
                <a:gridCol w="646775">
                  <a:extLst>
                    <a:ext uri="{9D8B030D-6E8A-4147-A177-3AD203B41FA5}">
                      <a16:colId xmlns:a16="http://schemas.microsoft.com/office/drawing/2014/main" val="2302718614"/>
                    </a:ext>
                  </a:extLst>
                </a:gridCol>
              </a:tblGrid>
              <a:tr h="173793">
                <a:tc gridSpan="6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alysis of variance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1402306"/>
                  </a:ext>
                </a:extLst>
              </a:tr>
              <a:tr h="5375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 summary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e means signif. Different (P&lt;0.05)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groups</a:t>
                      </a:r>
                      <a:endParaRPr lang="es-MX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square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00280908"/>
                  </a:ext>
                </a:extLst>
              </a:tr>
              <a:tr h="17379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1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5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81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70814362"/>
                  </a:ext>
                </a:extLst>
              </a:tr>
              <a:tr h="1912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1958771"/>
                  </a:ext>
                </a:extLst>
              </a:tr>
              <a:tr h="17379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OVA table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1364980"/>
                  </a:ext>
                </a:extLst>
              </a:tr>
              <a:tr h="1912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 (between columns)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4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7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88427964"/>
                  </a:ext>
                </a:extLst>
              </a:tr>
              <a:tr h="1912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 (within columns)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934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56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262896"/>
                  </a:ext>
                </a:extLst>
              </a:tr>
              <a:tr h="1912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33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s-MX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2657525"/>
                  </a:ext>
                </a:extLst>
              </a:tr>
              <a:tr h="1912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620062"/>
                  </a:ext>
                </a:extLst>
              </a:tr>
              <a:tr h="17379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key´s multiple comparison test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diff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p&lt;0.05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5808674"/>
                  </a:ext>
                </a:extLst>
              </a:tr>
              <a:tr h="191214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bP_hGH vs commercial hGH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bP_hGH vs BSA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356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5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416625"/>
                  </a:ext>
                </a:extLst>
              </a:tr>
              <a:tr h="191214">
                <a:tc v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69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11</a:t>
                      </a:r>
                      <a:endParaRPr lang="es-MX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s-MX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s-MX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15090870"/>
                  </a:ext>
                </a:extLst>
              </a:tr>
              <a:tr h="17379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mercial hGH vs BSA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04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96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s-MX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MX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8679875"/>
                  </a:ext>
                </a:extLst>
              </a:tr>
            </a:tbl>
          </a:graphicData>
        </a:graphic>
      </p:graphicFrame>
      <p:sp>
        <p:nvSpPr>
          <p:cNvPr id="6" name="Rectángulo 5">
            <a:extLst>
              <a:ext uri="{FF2B5EF4-FFF2-40B4-BE49-F238E27FC236}">
                <a16:creationId xmlns:a16="http://schemas.microsoft.com/office/drawing/2014/main" id="{C4E14FFF-ED16-42B0-87C4-C1FDE5C0FFB8}"/>
              </a:ext>
            </a:extLst>
          </p:cNvPr>
          <p:cNvSpPr/>
          <p:nvPr/>
        </p:nvSpPr>
        <p:spPr>
          <a:xfrm>
            <a:off x="2830184" y="4901592"/>
            <a:ext cx="653163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1S. Statistical analysis of the cell proliferation assay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key´s test was used to calculate statistical significance. One-way ANOVA was used for multiple group comparisons (*p&lt;0.05). </a:t>
            </a:r>
          </a:p>
        </p:txBody>
      </p:sp>
    </p:spTree>
    <p:extLst>
      <p:ext uri="{BB962C8B-B14F-4D97-AF65-F5344CB8AC3E}">
        <p14:creationId xmlns:p14="http://schemas.microsoft.com/office/powerpoint/2010/main" val="21508371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arcador de contenido 3">
            <a:extLst>
              <a:ext uri="{FF2B5EF4-FFF2-40B4-BE49-F238E27FC236}">
                <a16:creationId xmlns:a16="http://schemas.microsoft.com/office/drawing/2014/main" id="{E1CDE8C6-0833-425E-9F03-C2BB65C95902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8486" y="728627"/>
            <a:ext cx="6175371" cy="4351338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DA45BBFF-E615-48CA-94F5-A5EAD31E61FC}"/>
              </a:ext>
            </a:extLst>
          </p:cNvPr>
          <p:cNvSpPr/>
          <p:nvPr/>
        </p:nvSpPr>
        <p:spPr>
          <a:xfrm>
            <a:off x="2438400" y="5555049"/>
            <a:ext cx="6742176" cy="574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1S. 12% SDS-PAGE analysis of SmbP_hGH after first IMAC purification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ne 1: protein marker; Lane 2: periplasmic hypotonic fraction; Lane 3: periplasmic hypertonic fraction; Lane 4: flow-through; Lane 5-51 elution fractions.</a:t>
            </a:r>
            <a:endParaRPr lang="es-MX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4961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010237F3-1AF3-4062-9AD7-B72700A3C5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66"/>
          <a:stretch/>
        </p:blipFill>
        <p:spPr>
          <a:xfrm>
            <a:off x="4286750" y="1535159"/>
            <a:ext cx="3618498" cy="3207529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803329AC-20B9-4DEB-BF06-4CF583F36E16}"/>
              </a:ext>
            </a:extLst>
          </p:cNvPr>
          <p:cNvSpPr/>
          <p:nvPr/>
        </p:nvSpPr>
        <p:spPr>
          <a:xfrm>
            <a:off x="3641557" y="5342755"/>
            <a:ext cx="4908885" cy="9036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2S. Cell proliferation assay of purified hGH in the Nb2-11 cell line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b2-11 cells were exposure to 50 ng/ml of purified hGH, commercial hGH, and bovine serum albumin as a contro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e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olyhistidin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ged enterokinase was used to cleave SmbP from hGH, thus, after second IMAC purification, the enterokinase enzyme was completely removed.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60679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</TotalTime>
  <Words>240</Words>
  <Application>Microsoft Macintosh PowerPoint</Application>
  <PresentationFormat>Widescreen</PresentationFormat>
  <Paragraphs>5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vid Antonio Perez Perez</dc:creator>
  <cp:lastModifiedBy>XRISTO ZARATE KALFOPULOS</cp:lastModifiedBy>
  <cp:revision>13</cp:revision>
  <dcterms:created xsi:type="dcterms:W3CDTF">2020-01-30T04:57:46Z</dcterms:created>
  <dcterms:modified xsi:type="dcterms:W3CDTF">2020-01-30T21:32:51Z</dcterms:modified>
</cp:coreProperties>
</file>